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7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73563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3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948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9707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310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114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325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571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520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212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128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F83B32-8679-4ECC-92B3-BC2E54EE5E61}" type="datetimeFigureOut">
              <a:rPr lang="en-US" smtClean="0"/>
              <a:t>8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F4CEA-E676-4095-80B4-52EDC10842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774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492" y="464378"/>
            <a:ext cx="3101340" cy="1682496"/>
          </a:xfrm>
          <a:prstGeom prst="rect">
            <a:avLst/>
          </a:prstGeom>
        </p:spPr>
      </p:pic>
      <p:cxnSp>
        <p:nvCxnSpPr>
          <p:cNvPr id="7" name="Straight Arrow Connector 6"/>
          <p:cNvCxnSpPr/>
          <p:nvPr/>
        </p:nvCxnSpPr>
        <p:spPr>
          <a:xfrm flipH="1">
            <a:off x="3560642" y="1194374"/>
            <a:ext cx="38100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840302" y="151957"/>
            <a:ext cx="10708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unrelated blot</a:t>
            </a:r>
            <a:endParaRPr lang="en-US" sz="12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2611032" y="119940"/>
            <a:ext cx="418707" cy="27700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NIH</a:t>
            </a:r>
            <a:endParaRPr lang="en-US" sz="1200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2757823" y="114329"/>
            <a:ext cx="429928" cy="2770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UCL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3083068" y="114331"/>
            <a:ext cx="4187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NIH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3207180" y="108720"/>
            <a:ext cx="4299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UCL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3944690" y="1055874"/>
            <a:ext cx="8580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PIP5K2</a:t>
            </a:r>
            <a:endParaRPr lang="en-US" sz="1200" dirty="0"/>
          </a:p>
        </p:txBody>
      </p:sp>
      <p:grpSp>
        <p:nvGrpSpPr>
          <p:cNvPr id="43" name="Group 42"/>
          <p:cNvGrpSpPr/>
          <p:nvPr/>
        </p:nvGrpSpPr>
        <p:grpSpPr>
          <a:xfrm>
            <a:off x="96293" y="2240742"/>
            <a:ext cx="2794931" cy="2470562"/>
            <a:chOff x="1692307" y="2255505"/>
            <a:chExt cx="2794931" cy="2470562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0183" y="2696099"/>
              <a:ext cx="1106424" cy="2029968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 rot="16200000">
              <a:off x="2153142" y="2337579"/>
              <a:ext cx="4187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NIH</a:t>
              </a:r>
              <a:endParaRPr lang="en-US" sz="1200" dirty="0"/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2299932" y="2331968"/>
              <a:ext cx="4299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UCL</a:t>
              </a:r>
              <a:endParaRPr lang="en-US" sz="1200" dirty="0"/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2714160" y="2337579"/>
              <a:ext cx="41870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NIH</a:t>
              </a:r>
              <a:endParaRPr lang="en-US" sz="1200" dirty="0"/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2838272" y="2331968"/>
              <a:ext cx="4299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UCL</a:t>
              </a:r>
              <a:endParaRPr lang="en-US" sz="1200" dirty="0"/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 flipH="1">
              <a:off x="3245178" y="3325327"/>
              <a:ext cx="381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/>
            <p:cNvSpPr txBox="1"/>
            <p:nvPr/>
          </p:nvSpPr>
          <p:spPr>
            <a:xfrm>
              <a:off x="3629226" y="3186827"/>
              <a:ext cx="8580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PPIP5K1</a:t>
              </a:r>
              <a:endParaRPr lang="en-US" sz="12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692307" y="3325326"/>
              <a:ext cx="8580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130</a:t>
              </a:r>
              <a:endParaRPr lang="en-US" sz="1200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692307" y="3057101"/>
              <a:ext cx="8580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250</a:t>
              </a:r>
              <a:endParaRPr lang="en-US" sz="1200" dirty="0"/>
            </a:p>
          </p:txBody>
        </p:sp>
      </p:grpSp>
      <p:pic>
        <p:nvPicPr>
          <p:cNvPr id="30" name="Picture 2" descr="U:\scanning\5-20-15 c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 flipV="1">
            <a:off x="2757527" y="2629639"/>
            <a:ext cx="1903412" cy="6143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Box 30"/>
          <p:cNvSpPr txBox="1"/>
          <p:nvPr/>
        </p:nvSpPr>
        <p:spPr>
          <a:xfrm>
            <a:off x="228600" y="5863298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50</a:t>
            </a:r>
            <a:endParaRPr lang="en-US" dirty="0"/>
          </a:p>
        </p:txBody>
      </p:sp>
      <p:sp>
        <p:nvSpPr>
          <p:cNvPr id="32" name="TextBox 31"/>
          <p:cNvSpPr txBox="1"/>
          <p:nvPr/>
        </p:nvSpPr>
        <p:spPr>
          <a:xfrm>
            <a:off x="228600" y="6129915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30</a:t>
            </a:r>
            <a:endParaRPr lang="en-US" dirty="0"/>
          </a:p>
        </p:txBody>
      </p:sp>
      <p:sp>
        <p:nvSpPr>
          <p:cNvPr id="33" name="TextBox 32"/>
          <p:cNvSpPr txBox="1"/>
          <p:nvPr/>
        </p:nvSpPr>
        <p:spPr>
          <a:xfrm>
            <a:off x="345620" y="6314581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95</a:t>
            </a:r>
            <a:endParaRPr lang="en-US" dirty="0"/>
          </a:p>
        </p:txBody>
      </p:sp>
      <p:sp>
        <p:nvSpPr>
          <p:cNvPr id="34" name="TextBox 33"/>
          <p:cNvSpPr txBox="1"/>
          <p:nvPr/>
        </p:nvSpPr>
        <p:spPr>
          <a:xfrm>
            <a:off x="2901892" y="5716991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35" name="TextBox 34"/>
          <p:cNvSpPr txBox="1"/>
          <p:nvPr/>
        </p:nvSpPr>
        <p:spPr>
          <a:xfrm>
            <a:off x="3367504" y="5718982"/>
            <a:ext cx="683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K1KO</a:t>
            </a:r>
            <a:endParaRPr 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4116693" y="5716991"/>
            <a:ext cx="683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K2KO</a:t>
            </a:r>
            <a:endParaRPr lang="en-US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2972787" y="6047964"/>
            <a:ext cx="3304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3400601" y="6047142"/>
            <a:ext cx="578749" cy="8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4081854" y="6047142"/>
            <a:ext cx="666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4" name="Picture 4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8936" y="1600200"/>
            <a:ext cx="3843528" cy="2359152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6568095" y="3430774"/>
            <a:ext cx="7870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unrelated</a:t>
            </a:r>
          </a:p>
          <a:p>
            <a:r>
              <a:rPr lang="en-US" sz="1200" dirty="0" smtClean="0">
                <a:solidFill>
                  <a:schemeClr val="bg1"/>
                </a:solidFill>
              </a:rPr>
              <a:t>lanes</a:t>
            </a:r>
            <a:endParaRPr lang="en-US" sz="1200" dirty="0">
              <a:solidFill>
                <a:schemeClr val="bg1"/>
              </a:solidFill>
            </a:endParaRPr>
          </a:p>
        </p:txBody>
      </p:sp>
      <p:cxnSp>
        <p:nvCxnSpPr>
          <p:cNvPr id="46" name="Straight Connector 45"/>
          <p:cNvCxnSpPr/>
          <p:nvPr/>
        </p:nvCxnSpPr>
        <p:spPr>
          <a:xfrm>
            <a:off x="6553199" y="3319337"/>
            <a:ext cx="7870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5410200" y="3319337"/>
            <a:ext cx="787075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5443728" y="3430775"/>
            <a:ext cx="7870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unrelated</a:t>
            </a:r>
          </a:p>
          <a:p>
            <a:r>
              <a:rPr lang="en-US" sz="1200" dirty="0" smtClean="0">
                <a:solidFill>
                  <a:schemeClr val="bg1"/>
                </a:solidFill>
              </a:rPr>
              <a:t>lanes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851046" y="5638800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WT</a:t>
            </a:r>
            <a:endParaRPr lang="en-US" dirty="0"/>
          </a:p>
        </p:txBody>
      </p:sp>
      <p:sp>
        <p:nvSpPr>
          <p:cNvPr id="48" name="TextBox 47"/>
          <p:cNvSpPr txBox="1"/>
          <p:nvPr/>
        </p:nvSpPr>
        <p:spPr>
          <a:xfrm>
            <a:off x="1318721" y="5638800"/>
            <a:ext cx="683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K1KO</a:t>
            </a:r>
            <a:endParaRPr lang="en-US" dirty="0"/>
          </a:p>
        </p:txBody>
      </p:sp>
      <p:sp>
        <p:nvSpPr>
          <p:cNvPr id="49" name="TextBox 48"/>
          <p:cNvSpPr txBox="1"/>
          <p:nvPr/>
        </p:nvSpPr>
        <p:spPr>
          <a:xfrm>
            <a:off x="2065847" y="5638800"/>
            <a:ext cx="6834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K2KO</a:t>
            </a:r>
            <a:endParaRPr lang="en-US" dirty="0"/>
          </a:p>
        </p:txBody>
      </p:sp>
      <p:cxnSp>
        <p:nvCxnSpPr>
          <p:cNvPr id="50" name="Straight Connector 49"/>
          <p:cNvCxnSpPr/>
          <p:nvPr/>
        </p:nvCxnSpPr>
        <p:spPr>
          <a:xfrm>
            <a:off x="921941" y="5969773"/>
            <a:ext cx="3304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>
            <a:off x="1327498" y="5968951"/>
            <a:ext cx="601006" cy="8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2031008" y="5968951"/>
            <a:ext cx="66616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96293" y="464378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56" name="TextBox 55"/>
          <p:cNvSpPr txBox="1"/>
          <p:nvPr/>
        </p:nvSpPr>
        <p:spPr>
          <a:xfrm>
            <a:off x="96293" y="249667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57" name="TextBox 56"/>
          <p:cNvSpPr txBox="1"/>
          <p:nvPr/>
        </p:nvSpPr>
        <p:spPr>
          <a:xfrm>
            <a:off x="3993773" y="16002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58" name="TextBox 57"/>
          <p:cNvSpPr txBox="1"/>
          <p:nvPr/>
        </p:nvSpPr>
        <p:spPr>
          <a:xfrm>
            <a:off x="237256" y="487680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cxnSp>
        <p:nvCxnSpPr>
          <p:cNvPr id="60" name="Straight Connector 59"/>
          <p:cNvCxnSpPr/>
          <p:nvPr/>
        </p:nvCxnSpPr>
        <p:spPr>
          <a:xfrm flipV="1">
            <a:off x="655708" y="428956"/>
            <a:ext cx="1751867" cy="343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>
            <a:off x="1697378" y="6086323"/>
            <a:ext cx="3048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/>
          <p:cNvCxnSpPr/>
          <p:nvPr/>
        </p:nvCxnSpPr>
        <p:spPr>
          <a:xfrm flipH="1">
            <a:off x="4041308" y="6335344"/>
            <a:ext cx="304800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8077200" y="50870"/>
            <a:ext cx="7280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2 Fi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14131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3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NIEH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MP</dc:creator>
  <cp:lastModifiedBy>TEMP</cp:lastModifiedBy>
  <cp:revision>2</cp:revision>
  <dcterms:created xsi:type="dcterms:W3CDTF">2016-08-10T18:36:31Z</dcterms:created>
  <dcterms:modified xsi:type="dcterms:W3CDTF">2016-08-10T18:37:38Z</dcterms:modified>
</cp:coreProperties>
</file>